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6" r:id="rId2"/>
    <p:sldId id="257" r:id="rId3"/>
    <p:sldId id="258" r:id="rId4"/>
    <p:sldId id="259" r:id="rId5"/>
    <p:sldId id="260" r:id="rId6"/>
    <p:sldId id="262" r:id="rId7"/>
    <p:sldId id="263" r:id="rId8"/>
  </p:sldIdLst>
  <p:sldSz cx="12192000" cy="6858000"/>
  <p:notesSz cx="6858000" cy="9144000"/>
  <p:defaultTextStyle>
    <a:defPPr>
      <a:defRPr lang="es-C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16" autoAdjust="0"/>
    <p:restoredTop sz="88302" autoAdjust="0"/>
  </p:normalViewPr>
  <p:slideViewPr>
    <p:cSldViewPr snapToGrid="0">
      <p:cViewPr varScale="1">
        <p:scale>
          <a:sx n="76" d="100"/>
          <a:sy n="76" d="100"/>
        </p:scale>
        <p:origin x="715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CO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7E16CCB-1619-45E7-9811-71FBDDDB0697}" type="datetimeFigureOut">
              <a:rPr lang="es-CO" smtClean="0"/>
              <a:t>10/03/2023</a:t>
            </a:fld>
            <a:endParaRPr lang="es-CO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CO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CO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758E1C1-6D5E-42E2-851A-AD7F303C6B03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6824187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s-ES" dirty="0"/>
              <a:t>Figure S1</a:t>
            </a:r>
            <a:endParaRPr lang="es-CO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758E1C1-6D5E-42E2-851A-AD7F303C6B03}" type="slidenum">
              <a:rPr lang="es-CO" smtClean="0"/>
              <a:t>1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91069430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s-ES" dirty="0"/>
              <a:t>Figures S2</a:t>
            </a:r>
            <a:endParaRPr lang="es-CO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758E1C1-6D5E-42E2-851A-AD7F303C6B03}" type="slidenum">
              <a:rPr lang="es-CO" smtClean="0"/>
              <a:t>2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42197571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s-ES" dirty="0"/>
              <a:t>Figures S3</a:t>
            </a:r>
            <a:endParaRPr lang="es-CO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758E1C1-6D5E-42E2-851A-AD7F303C6B03}" type="slidenum">
              <a:rPr kumimoji="0" lang="es-CO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</a:t>
            </a:fld>
            <a:endParaRPr kumimoji="0" lang="es-CO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0218063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s-ES" dirty="0"/>
              <a:t>Figures S4</a:t>
            </a:r>
            <a:endParaRPr lang="es-CO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758E1C1-6D5E-42E2-851A-AD7F303C6B03}" type="slidenum">
              <a:rPr kumimoji="0" lang="es-CO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4</a:t>
            </a:fld>
            <a:endParaRPr kumimoji="0" lang="es-CO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98062724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s-ES" dirty="0"/>
              <a:t>Figures S5</a:t>
            </a:r>
            <a:endParaRPr lang="es-CO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758E1C1-6D5E-42E2-851A-AD7F303C6B03}" type="slidenum">
              <a:rPr kumimoji="0" lang="es-CO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5</a:t>
            </a:fld>
            <a:endParaRPr kumimoji="0" lang="es-CO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9372994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s-ES" dirty="0"/>
              <a:t>Figures 6</a:t>
            </a:r>
            <a:endParaRPr lang="es-CO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758E1C1-6D5E-42E2-851A-AD7F303C6B03}" type="slidenum">
              <a:rPr kumimoji="0" lang="es-CO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6</a:t>
            </a:fld>
            <a:endParaRPr kumimoji="0" lang="es-CO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68560668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s-ES" dirty="0"/>
              <a:t>Figures 7</a:t>
            </a:r>
            <a:endParaRPr lang="es-CO" dirty="0"/>
          </a:p>
          <a:p>
            <a:endParaRPr lang="es-CO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758E1C1-6D5E-42E2-851A-AD7F303C6B03}" type="slidenum">
              <a:rPr lang="es-CO" smtClean="0"/>
              <a:t>7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1541661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1BA9A00-E00D-68D6-6117-A116A9AF3AC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FE91DEF7-25CB-938A-61EE-F336F986A4B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850EE64-ADEE-A86E-3281-E074374D23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BD009-8D9F-483C-BFE8-506C5034B88E}" type="datetimeFigureOut">
              <a:rPr lang="es-CO" smtClean="0"/>
              <a:t>10/03/2023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89AE112-80A7-BF38-7EB8-34AD07FC7F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36D1392-785A-2D57-27D5-20FC6666F6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33CEE1-C321-46DF-8960-D6686299C81B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8019499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3FAFBDD-AF3E-41A7-1D02-10B35CAFB9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F06B4628-325A-73B6-584F-236FD05F7A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CEF30A1-9A88-C53D-75AE-DE12D3F21C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BD009-8D9F-483C-BFE8-506C5034B88E}" type="datetimeFigureOut">
              <a:rPr lang="es-CO" smtClean="0"/>
              <a:t>10/03/2023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F8B40E5-7F9A-1B0B-132D-752AD20E48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7AD5724-9CA9-C0AA-1302-5E4561D255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33CEE1-C321-46DF-8960-D6686299C81B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759853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5999A483-55AB-4DAC-E05C-3A3CF16D31A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A8EDB105-CE56-C2F7-F1D5-A2E9F3F3C2C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D1F35BA-4B82-B4D8-7344-C02C876067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BD009-8D9F-483C-BFE8-506C5034B88E}" type="datetimeFigureOut">
              <a:rPr lang="es-CO" smtClean="0"/>
              <a:t>10/03/2023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33BC23D-5D87-CA55-5B12-EA715201BC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7186B9F-7C2E-55A8-DCE0-EF02803D2A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33CEE1-C321-46DF-8960-D6686299C81B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167790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BEB4B68-1FD6-5835-EC8C-A6F96D960B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BD0B7954-86F4-2B15-B1BD-8AE8AD8C5DE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F681E95-B4D7-AED9-C7C7-95E3135E6B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BD009-8D9F-483C-BFE8-506C5034B88E}" type="datetimeFigureOut">
              <a:rPr lang="es-CO" smtClean="0"/>
              <a:t>10/03/2023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541AE67-7D8F-C240-BDF5-965484202B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4A70F95-29A7-95FB-FDEC-345A057A44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33CEE1-C321-46DF-8960-D6686299C81B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338707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EF480A7-023B-0832-B1F3-D9BABEA8FE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C974C8EA-C0A6-5C84-0EA1-64ABAECE95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659742D-B780-6DD9-CD24-C2A2925BA8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BD009-8D9F-483C-BFE8-506C5034B88E}" type="datetimeFigureOut">
              <a:rPr lang="es-CO" smtClean="0"/>
              <a:t>10/03/2023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3650755-EC9F-0581-3DA6-7396ADDC22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E2C0BAE-8F07-204A-1009-B40E9B0559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33CEE1-C321-46DF-8960-D6686299C81B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8556830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417DB12-10F6-2C8B-A2F1-B021DB497B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382AED69-E962-BD3F-8A5A-2F6D3502B27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BA9A3C1E-05DC-65E9-DB46-BD72CBA751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E70C21EB-5392-BAF0-F9CF-71CFFD1209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BD009-8D9F-483C-BFE8-506C5034B88E}" type="datetimeFigureOut">
              <a:rPr lang="es-CO" smtClean="0"/>
              <a:t>10/03/2023</a:t>
            </a:fld>
            <a:endParaRPr lang="es-CO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DDEB01D-2216-5E62-3909-DCD3848316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7ABC6584-2827-8737-04DB-EDFEF0E865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33CEE1-C321-46DF-8960-D6686299C81B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9863327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650E206-8C9D-6114-34F9-C922B5F2E3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90617EB8-ACA1-A6CE-A33D-05EED787C2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12A476D4-98B5-3BCB-2544-907BFF4677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45CE5112-94F4-2BB5-F756-94CCCE53B06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45BEB66F-A72E-39F5-7793-5225DB538AB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F8C600D5-0730-D232-1409-2C8F2C7E77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BD009-8D9F-483C-BFE8-506C5034B88E}" type="datetimeFigureOut">
              <a:rPr lang="es-CO" smtClean="0"/>
              <a:t>10/03/2023</a:t>
            </a:fld>
            <a:endParaRPr lang="es-CO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2D287478-F44C-F775-E221-71F2FC2B0C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A5F5D0D7-BA0E-22B9-A8DF-E7A50E4698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33CEE1-C321-46DF-8960-D6686299C81B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4805124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081068C-50AA-9DA5-A931-90E8BA9EAA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ECD0426F-FE96-3DAE-64AB-8EBBA2F027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BD009-8D9F-483C-BFE8-506C5034B88E}" type="datetimeFigureOut">
              <a:rPr lang="es-CO" smtClean="0"/>
              <a:t>10/03/2023</a:t>
            </a:fld>
            <a:endParaRPr lang="es-CO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D8E2DEB6-4B95-C800-A275-917377346C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A7BD57F1-AA4A-FA17-E3BF-18BC7F1448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33CEE1-C321-46DF-8960-D6686299C81B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8622128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557D01A1-2442-47A3-736C-406C759A88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BD009-8D9F-483C-BFE8-506C5034B88E}" type="datetimeFigureOut">
              <a:rPr lang="es-CO" smtClean="0"/>
              <a:t>10/03/2023</a:t>
            </a:fld>
            <a:endParaRPr lang="es-CO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AA9FD061-561F-BF91-D852-FFB95C5E58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62F2E051-338B-7DF6-FECD-4287E6396D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33CEE1-C321-46DF-8960-D6686299C81B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513147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A07160C-C3C2-04EA-98E7-F0174536D7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533A3DBD-9E0D-B4DE-55D9-A4C2A3118FD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A7F34278-4094-12A0-F95A-62DC0C34D5C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8F88E7EA-5EE6-3C37-04B5-130F0B256A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BD009-8D9F-483C-BFE8-506C5034B88E}" type="datetimeFigureOut">
              <a:rPr lang="es-CO" smtClean="0"/>
              <a:t>10/03/2023</a:t>
            </a:fld>
            <a:endParaRPr lang="es-CO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46FD85CF-A05C-1F48-5617-2E5E07887A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2477E5A7-0CF2-B191-E91B-1DEEE3CE17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33CEE1-C321-46DF-8960-D6686299C81B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2344931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9914323-9730-0F5B-2C5C-1ED98CF36E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2CC6FA45-80C4-425E-13B3-F991C57C3F7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O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CF41728C-23B5-9F90-D4DC-544E380DD4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490682CF-408D-EA84-BE60-7096D5D8FC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BD009-8D9F-483C-BFE8-506C5034B88E}" type="datetimeFigureOut">
              <a:rPr lang="es-CO" smtClean="0"/>
              <a:t>10/03/2023</a:t>
            </a:fld>
            <a:endParaRPr lang="es-CO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F056BAD3-ED71-294A-209F-CA62CCFB0B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2D2A84FE-B2D8-A4BB-1D3F-0D03779F37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33CEE1-C321-46DF-8960-D6686299C81B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8072127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843B8D8E-FA2B-04AB-6CC2-E6245DA854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52D5CE3C-C0E2-BC6D-420D-30B8B67E72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3F12538-C774-CE78-419B-E97AB623E0E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4BD009-8D9F-483C-BFE8-506C5034B88E}" type="datetimeFigureOut">
              <a:rPr lang="es-CO" smtClean="0"/>
              <a:t>10/03/2023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EABCEFD-7D50-3906-CE37-4E0C7B26300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365F6E1-5EC7-5FC2-FAE3-A6F02695A6A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33CEE1-C321-46DF-8960-D6686299C81B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446543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>
            <a:extLst>
              <a:ext uri="{FF2B5EF4-FFF2-40B4-BE49-F238E27FC236}">
                <a16:creationId xmlns:a16="http://schemas.microsoft.com/office/drawing/2014/main" id="{CEFDD6E4-19A8-BA96-47D1-F4C06BB261F1}"/>
              </a:ext>
            </a:extLst>
          </p:cNvPr>
          <p:cNvSpPr txBox="1"/>
          <p:nvPr/>
        </p:nvSpPr>
        <p:spPr>
          <a:xfrm>
            <a:off x="1166394" y="913504"/>
            <a:ext cx="284382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ZA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SP1</a:t>
            </a:r>
            <a:r>
              <a:rPr lang="en-ZA" sz="1400" b="1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2-61</a:t>
            </a:r>
            <a:r>
              <a:rPr lang="en-ZA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native fragment</a:t>
            </a:r>
            <a:endParaRPr lang="es-CO" sz="1400" b="1" dirty="0"/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622D8803-F95E-A58C-EB40-52C06D3AD256}"/>
              </a:ext>
            </a:extLst>
          </p:cNvPr>
          <p:cNvSpPr txBox="1"/>
          <p:nvPr/>
        </p:nvSpPr>
        <p:spPr>
          <a:xfrm>
            <a:off x="4375483" y="913504"/>
            <a:ext cx="344103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ZA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SP-M51-</a:t>
            </a:r>
            <a:r>
              <a:rPr lang="en-ZA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  <a:sym typeface="Symbol" panose="05050102010706020507" pitchFamily="18" charset="2"/>
              </a:rPr>
              <a:t></a:t>
            </a:r>
            <a:r>
              <a:rPr lang="en-ZA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[CH2NH]-V52 (B1 </a:t>
            </a:r>
            <a:r>
              <a:rPr lang="en-ZA" sz="14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alog</a:t>
            </a:r>
            <a:r>
              <a:rPr lang="en-ZA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#2)</a:t>
            </a:r>
            <a:endParaRPr lang="es-CO" sz="1400" b="1" dirty="0"/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EF581207-79AB-3573-8053-61832EAE1F77}"/>
              </a:ext>
            </a:extLst>
          </p:cNvPr>
          <p:cNvSpPr txBox="1"/>
          <p:nvPr/>
        </p:nvSpPr>
        <p:spPr>
          <a:xfrm>
            <a:off x="8181776" y="862791"/>
            <a:ext cx="312821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ZA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SP-V52-</a:t>
            </a:r>
            <a:r>
              <a:rPr lang="en-ZA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  <a:sym typeface="Symbol" panose="05050102010706020507" pitchFamily="18" charset="2"/>
              </a:rPr>
              <a:t></a:t>
            </a:r>
            <a:r>
              <a:rPr lang="en-ZA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[CH2NH]-L53 (B1 </a:t>
            </a:r>
            <a:r>
              <a:rPr lang="en-ZA" sz="14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alog</a:t>
            </a:r>
            <a:r>
              <a:rPr lang="en-ZA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#1)</a:t>
            </a:r>
            <a:endParaRPr lang="es-CO" sz="1400" b="1" dirty="0"/>
          </a:p>
        </p:txBody>
      </p:sp>
      <p:pic>
        <p:nvPicPr>
          <p:cNvPr id="11" name="Picture 1" descr="Chart, box and whisker chart&#10;&#10;Description automatically generated">
            <a:extLst>
              <a:ext uri="{FF2B5EF4-FFF2-40B4-BE49-F238E27FC236}">
                <a16:creationId xmlns:a16="http://schemas.microsoft.com/office/drawing/2014/main" id="{CB644947-7AEB-3F50-77C7-AD8B1D8B74DF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720"/>
          <a:stretch/>
        </p:blipFill>
        <p:spPr>
          <a:xfrm>
            <a:off x="323116" y="1251803"/>
            <a:ext cx="11343020" cy="534707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0B0B5DA-1DAD-44F8-ADF4-3FD2ACEB3E1C}"/>
              </a:ext>
            </a:extLst>
          </p:cNvPr>
          <p:cNvSpPr txBox="1"/>
          <p:nvPr/>
        </p:nvSpPr>
        <p:spPr>
          <a:xfrm>
            <a:off x="664866" y="185938"/>
            <a:ext cx="1062110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1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: RMSD pattern changes in MSP1</a:t>
            </a:r>
            <a:r>
              <a:rPr lang="en-US" sz="18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42–61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native fragment, MSP1-M</a:t>
            </a:r>
            <a:r>
              <a:rPr lang="en-US" sz="18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51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ψ[</a:t>
            </a:r>
            <a:r>
              <a:rPr lang="en-US" sz="1800" baseline="-25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H2NH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]-V</a:t>
            </a:r>
            <a:r>
              <a:rPr lang="en-US" sz="18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52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(B1 analog 2) and MSP1-V</a:t>
            </a:r>
            <a:r>
              <a:rPr lang="en-US" sz="18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52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ψ[CH</a:t>
            </a:r>
            <a:r>
              <a:rPr lang="en-US" sz="1800" baseline="-25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H]-L</a:t>
            </a:r>
            <a:r>
              <a:rPr lang="en-US" sz="18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53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(B1 analog 1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836482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upo 11">
            <a:extLst>
              <a:ext uri="{FF2B5EF4-FFF2-40B4-BE49-F238E27FC236}">
                <a16:creationId xmlns:a16="http://schemas.microsoft.com/office/drawing/2014/main" id="{2B55986F-D264-F0C8-D4D3-06F7BEA5A81C}"/>
              </a:ext>
            </a:extLst>
          </p:cNvPr>
          <p:cNvGrpSpPr/>
          <p:nvPr/>
        </p:nvGrpSpPr>
        <p:grpSpPr>
          <a:xfrm>
            <a:off x="527496" y="951785"/>
            <a:ext cx="11208979" cy="5519354"/>
            <a:chOff x="567690" y="700575"/>
            <a:chExt cx="11389270" cy="5687525"/>
          </a:xfrm>
        </p:grpSpPr>
        <p:sp>
          <p:nvSpPr>
            <p:cNvPr id="5" name="CuadroTexto 4">
              <a:extLst>
                <a:ext uri="{FF2B5EF4-FFF2-40B4-BE49-F238E27FC236}">
                  <a16:creationId xmlns:a16="http://schemas.microsoft.com/office/drawing/2014/main" id="{2F93E31D-DE18-75B5-00BF-32E32A601F1F}"/>
                </a:ext>
              </a:extLst>
            </p:cNvPr>
            <p:cNvSpPr txBox="1"/>
            <p:nvPr/>
          </p:nvSpPr>
          <p:spPr>
            <a:xfrm>
              <a:off x="1449746" y="700575"/>
              <a:ext cx="2843829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ZA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SP1</a:t>
              </a:r>
              <a:r>
                <a:rPr lang="en-ZA" sz="1400" b="1" baseline="300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42-61</a:t>
              </a:r>
              <a:r>
                <a:rPr lang="en-ZA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native fragment</a:t>
              </a:r>
              <a:endParaRPr lang="es-CO" sz="1400" b="1" dirty="0"/>
            </a:p>
          </p:txBody>
        </p:sp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77718D39-7752-4352-7FDE-3A0B557BE87C}"/>
                </a:ext>
              </a:extLst>
            </p:cNvPr>
            <p:cNvSpPr txBox="1"/>
            <p:nvPr/>
          </p:nvSpPr>
          <p:spPr>
            <a:xfrm>
              <a:off x="4578684" y="700575"/>
              <a:ext cx="3441033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ZA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SP-M51-</a:t>
              </a:r>
              <a:r>
                <a:rPr lang="en-ZA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  <a:sym typeface="Symbol" panose="05050102010706020507" pitchFamily="18" charset="2"/>
                </a:rPr>
                <a:t></a:t>
              </a:r>
              <a:r>
                <a:rPr lang="en-ZA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[CH2NH]-V52 (B1 </a:t>
              </a:r>
              <a:r>
                <a:rPr lang="en-ZA" sz="1400" b="1" dirty="0" err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nalog</a:t>
              </a:r>
              <a:r>
                <a:rPr lang="en-ZA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#2)</a:t>
              </a:r>
              <a:endParaRPr lang="es-CO" sz="1400" b="1" dirty="0"/>
            </a:p>
          </p:txBody>
        </p:sp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C8844BF2-872A-51AB-0FB6-29E2FA9A5831}"/>
                </a:ext>
              </a:extLst>
            </p:cNvPr>
            <p:cNvSpPr txBox="1"/>
            <p:nvPr/>
          </p:nvSpPr>
          <p:spPr>
            <a:xfrm>
              <a:off x="7897394" y="700575"/>
              <a:ext cx="3128212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ZA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SP-V52-</a:t>
              </a:r>
              <a:r>
                <a:rPr lang="en-ZA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  <a:sym typeface="Symbol" panose="05050102010706020507" pitchFamily="18" charset="2"/>
                </a:rPr>
                <a:t></a:t>
              </a:r>
              <a:r>
                <a:rPr lang="en-ZA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[CH2NH]-L53 (B1 </a:t>
              </a:r>
              <a:r>
                <a:rPr lang="en-ZA" sz="1400" b="1" dirty="0" err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nalog</a:t>
              </a:r>
              <a:r>
                <a:rPr lang="en-ZA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#1)</a:t>
              </a:r>
              <a:endParaRPr lang="es-CO" sz="1400" b="1" dirty="0"/>
            </a:p>
          </p:txBody>
        </p:sp>
        <p:pic>
          <p:nvPicPr>
            <p:cNvPr id="8" name="Picture 3" descr="Chart&#10;&#10;Description automatically generated">
              <a:extLst>
                <a:ext uri="{FF2B5EF4-FFF2-40B4-BE49-F238E27FC236}">
                  <a16:creationId xmlns:a16="http://schemas.microsoft.com/office/drawing/2014/main" id="{07B45193-7341-CF44-8BE3-4344527D914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377"/>
            <a:stretch/>
          </p:blipFill>
          <p:spPr>
            <a:xfrm>
              <a:off x="567690" y="999671"/>
              <a:ext cx="11389270" cy="5388429"/>
            </a:xfrm>
            <a:prstGeom prst="rect">
              <a:avLst/>
            </a:prstGeom>
          </p:spPr>
        </p:pic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id="{E537E3CC-BBFF-7BC5-AB25-15B14124581D}"/>
                </a:ext>
              </a:extLst>
            </p:cNvPr>
            <p:cNvSpPr txBox="1"/>
            <p:nvPr/>
          </p:nvSpPr>
          <p:spPr>
            <a:xfrm>
              <a:off x="1455185" y="3672378"/>
              <a:ext cx="2843829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-ZA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SP1</a:t>
              </a:r>
              <a:r>
                <a:rPr lang="en-ZA" sz="1400" b="1" baseline="300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42-61</a:t>
              </a:r>
              <a:r>
                <a:rPr lang="en-ZA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native fragment</a:t>
              </a:r>
              <a:endParaRPr lang="es-CO" sz="1400" b="1" dirty="0"/>
            </a:p>
          </p:txBody>
        </p:sp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1D950D30-1572-71F6-34EC-A0B7AE695BC9}"/>
                </a:ext>
              </a:extLst>
            </p:cNvPr>
            <p:cNvSpPr txBox="1"/>
            <p:nvPr/>
          </p:nvSpPr>
          <p:spPr>
            <a:xfrm>
              <a:off x="4584123" y="3672378"/>
              <a:ext cx="3441033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-ZA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SP-M51-</a:t>
              </a:r>
              <a:r>
                <a:rPr lang="en-ZA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  <a:sym typeface="Symbol" panose="05050102010706020507" pitchFamily="18" charset="2"/>
                </a:rPr>
                <a:t></a:t>
              </a:r>
              <a:r>
                <a:rPr lang="en-ZA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[CH2NH]-V52 (B1 </a:t>
              </a:r>
              <a:r>
                <a:rPr lang="en-ZA" sz="1400" b="1" dirty="0" err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nalog</a:t>
              </a:r>
              <a:r>
                <a:rPr lang="en-ZA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#2)</a:t>
              </a:r>
              <a:endParaRPr lang="es-CO" sz="1400" b="1" dirty="0"/>
            </a:p>
          </p:txBody>
        </p:sp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55088A4E-BDB0-F569-95E3-76A0F6F72291}"/>
                </a:ext>
              </a:extLst>
            </p:cNvPr>
            <p:cNvSpPr txBox="1"/>
            <p:nvPr/>
          </p:nvSpPr>
          <p:spPr>
            <a:xfrm>
              <a:off x="7902833" y="3672378"/>
              <a:ext cx="3128212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-ZA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SP-V52-</a:t>
              </a:r>
              <a:r>
                <a:rPr lang="en-ZA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  <a:sym typeface="Symbol" panose="05050102010706020507" pitchFamily="18" charset="2"/>
                </a:rPr>
                <a:t></a:t>
              </a:r>
              <a:r>
                <a:rPr lang="en-ZA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[CH2NH]-L53 (B1 </a:t>
              </a:r>
              <a:r>
                <a:rPr lang="en-ZA" sz="1400" b="1" dirty="0" err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nalog</a:t>
              </a:r>
              <a:r>
                <a:rPr lang="en-ZA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#1)</a:t>
              </a:r>
              <a:endParaRPr lang="es-CO" sz="1400" b="1" dirty="0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2F4A26B4-130E-49A2-B830-0DF0704E28DE}"/>
              </a:ext>
            </a:extLst>
          </p:cNvPr>
          <p:cNvSpPr txBox="1"/>
          <p:nvPr/>
        </p:nvSpPr>
        <p:spPr>
          <a:xfrm>
            <a:off x="1105319" y="120580"/>
            <a:ext cx="1038999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2: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radius of gyration (RG) changes in MSP1</a:t>
            </a:r>
            <a:r>
              <a:rPr lang="en-US" sz="18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42–61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native fragment, MSP1-M51-ψ[CH</a:t>
            </a:r>
            <a:r>
              <a:rPr lang="en-US" sz="1800" baseline="-25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H]-V52 (B1 analog 2), and MSP1-V52-ψ[CH</a:t>
            </a:r>
            <a:r>
              <a:rPr lang="en-US" sz="1800" baseline="-25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H]-L53 (B1 analog 1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717098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upo 6">
            <a:extLst>
              <a:ext uri="{FF2B5EF4-FFF2-40B4-BE49-F238E27FC236}">
                <a16:creationId xmlns:a16="http://schemas.microsoft.com/office/drawing/2014/main" id="{5DE75CEE-EE63-EDFB-E860-ABFBC1499093}"/>
              </a:ext>
            </a:extLst>
          </p:cNvPr>
          <p:cNvGrpSpPr/>
          <p:nvPr/>
        </p:nvGrpSpPr>
        <p:grpSpPr>
          <a:xfrm>
            <a:off x="268604" y="2478575"/>
            <a:ext cx="11384941" cy="3109425"/>
            <a:chOff x="268604" y="2478575"/>
            <a:chExt cx="11384941" cy="3109425"/>
          </a:xfrm>
        </p:grpSpPr>
        <p:sp>
          <p:nvSpPr>
            <p:cNvPr id="3" name="CuadroTexto 2">
              <a:extLst>
                <a:ext uri="{FF2B5EF4-FFF2-40B4-BE49-F238E27FC236}">
                  <a16:creationId xmlns:a16="http://schemas.microsoft.com/office/drawing/2014/main" id="{E5436B85-4685-87D5-4983-FC3316010D53}"/>
                </a:ext>
              </a:extLst>
            </p:cNvPr>
            <p:cNvSpPr txBox="1"/>
            <p:nvPr/>
          </p:nvSpPr>
          <p:spPr>
            <a:xfrm>
              <a:off x="1119546" y="2478575"/>
              <a:ext cx="2843829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ZA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SP1</a:t>
              </a:r>
              <a:r>
                <a:rPr lang="en-ZA" sz="1400" b="1" baseline="300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42-61</a:t>
              </a:r>
              <a:r>
                <a:rPr lang="en-ZA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native fragment</a:t>
              </a:r>
              <a:endParaRPr lang="es-CO" sz="1400" b="1" dirty="0"/>
            </a:p>
          </p:txBody>
        </p:sp>
        <p:sp>
          <p:nvSpPr>
            <p:cNvPr id="4" name="CuadroTexto 3">
              <a:extLst>
                <a:ext uri="{FF2B5EF4-FFF2-40B4-BE49-F238E27FC236}">
                  <a16:creationId xmlns:a16="http://schemas.microsoft.com/office/drawing/2014/main" id="{3B622C24-42E3-CB85-8234-33F546272F5D}"/>
                </a:ext>
              </a:extLst>
            </p:cNvPr>
            <p:cNvSpPr txBox="1"/>
            <p:nvPr/>
          </p:nvSpPr>
          <p:spPr>
            <a:xfrm>
              <a:off x="4248484" y="2478575"/>
              <a:ext cx="3441033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ZA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SP-M51-</a:t>
              </a:r>
              <a:r>
                <a:rPr lang="en-ZA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  <a:sym typeface="Symbol" panose="05050102010706020507" pitchFamily="18" charset="2"/>
                </a:rPr>
                <a:t></a:t>
              </a:r>
              <a:r>
                <a:rPr lang="en-ZA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[CH2NH]-V52 (B1 </a:t>
              </a:r>
              <a:r>
                <a:rPr lang="en-ZA" sz="1400" b="1" dirty="0" err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nalog</a:t>
              </a:r>
              <a:r>
                <a:rPr lang="en-ZA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#2)</a:t>
              </a:r>
              <a:endParaRPr lang="es-CO" sz="1400" b="1" dirty="0"/>
            </a:p>
          </p:txBody>
        </p:sp>
        <p:sp>
          <p:nvSpPr>
            <p:cNvPr id="5" name="CuadroTexto 4">
              <a:extLst>
                <a:ext uri="{FF2B5EF4-FFF2-40B4-BE49-F238E27FC236}">
                  <a16:creationId xmlns:a16="http://schemas.microsoft.com/office/drawing/2014/main" id="{54F0A56E-C2F1-43A9-C8E1-88FBB2547702}"/>
                </a:ext>
              </a:extLst>
            </p:cNvPr>
            <p:cNvSpPr txBox="1"/>
            <p:nvPr/>
          </p:nvSpPr>
          <p:spPr>
            <a:xfrm>
              <a:off x="7567194" y="2478575"/>
              <a:ext cx="3128212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ZA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SP-V52-</a:t>
              </a:r>
              <a:r>
                <a:rPr lang="en-ZA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  <a:sym typeface="Symbol" panose="05050102010706020507" pitchFamily="18" charset="2"/>
                </a:rPr>
                <a:t></a:t>
              </a:r>
              <a:r>
                <a:rPr lang="en-ZA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[CH2NH]-L53 (B1 </a:t>
              </a:r>
              <a:r>
                <a:rPr lang="en-ZA" sz="1400" b="1" dirty="0" err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nalog</a:t>
              </a:r>
              <a:r>
                <a:rPr lang="en-ZA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#1)</a:t>
              </a:r>
              <a:endParaRPr lang="es-CO" sz="1400" b="1" dirty="0"/>
            </a:p>
          </p:txBody>
        </p:sp>
        <p:pic>
          <p:nvPicPr>
            <p:cNvPr id="6" name="Picture 2" descr="Chart, histogram&#10;&#10;Description automatically generated">
              <a:extLst>
                <a:ext uri="{FF2B5EF4-FFF2-40B4-BE49-F238E27FC236}">
                  <a16:creationId xmlns:a16="http://schemas.microsoft.com/office/drawing/2014/main" id="{940EE62E-5872-6516-E78F-6E30CFEEE92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" t="5719" r="-1421" b="48341"/>
            <a:stretch/>
          </p:blipFill>
          <p:spPr bwMode="auto">
            <a:xfrm>
              <a:off x="268604" y="3009900"/>
              <a:ext cx="11384941" cy="2578100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1AC769FC-2B08-4B15-AAD4-07A8B2F376A3}"/>
              </a:ext>
            </a:extLst>
          </p:cNvPr>
          <p:cNvSpPr txBox="1"/>
          <p:nvPr/>
        </p:nvSpPr>
        <p:spPr>
          <a:xfrm>
            <a:off x="1225899" y="864158"/>
            <a:ext cx="98373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3: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MSF plot for MSP1</a:t>
            </a:r>
            <a:r>
              <a:rPr lang="en-US" sz="18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42–61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native fragment, MSP1-M51-ψ[CH</a:t>
            </a:r>
            <a:r>
              <a:rPr lang="en-US" sz="1800" baseline="-25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H]-V52 (B1 analog 2), and MSP1-V52-ψ[CH</a:t>
            </a:r>
            <a:r>
              <a:rPr lang="en-US" sz="1800" baseline="-25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H]-L53 (B1 analog 1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746901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upo 7">
            <a:extLst>
              <a:ext uri="{FF2B5EF4-FFF2-40B4-BE49-F238E27FC236}">
                <a16:creationId xmlns:a16="http://schemas.microsoft.com/office/drawing/2014/main" id="{9B70BDC8-BE8D-4EB1-9008-AC7B61084AA2}"/>
              </a:ext>
            </a:extLst>
          </p:cNvPr>
          <p:cNvGrpSpPr/>
          <p:nvPr/>
        </p:nvGrpSpPr>
        <p:grpSpPr>
          <a:xfrm>
            <a:off x="607686" y="2343768"/>
            <a:ext cx="10976627" cy="2715578"/>
            <a:chOff x="74379" y="2080236"/>
            <a:chExt cx="10976627" cy="2715578"/>
          </a:xfrm>
        </p:grpSpPr>
        <p:pic>
          <p:nvPicPr>
            <p:cNvPr id="7" name="Picture 9" descr="Chart, histogram&#10;&#10;Description automatically generated">
              <a:extLst>
                <a:ext uri="{FF2B5EF4-FFF2-40B4-BE49-F238E27FC236}">
                  <a16:creationId xmlns:a16="http://schemas.microsoft.com/office/drawing/2014/main" id="{C7EAC247-0AFE-FAB7-ED35-9F36E5842DB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0521"/>
            <a:stretch/>
          </p:blipFill>
          <p:spPr bwMode="auto">
            <a:xfrm>
              <a:off x="74379" y="2080236"/>
              <a:ext cx="10976627" cy="2715578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3" name="CuadroTexto 2">
              <a:extLst>
                <a:ext uri="{FF2B5EF4-FFF2-40B4-BE49-F238E27FC236}">
                  <a16:creationId xmlns:a16="http://schemas.microsoft.com/office/drawing/2014/main" id="{D7DDB19F-2DDC-D847-8506-25E595E154F7}"/>
                </a:ext>
              </a:extLst>
            </p:cNvPr>
            <p:cNvSpPr txBox="1"/>
            <p:nvPr/>
          </p:nvSpPr>
          <p:spPr>
            <a:xfrm>
              <a:off x="1144946" y="2102688"/>
              <a:ext cx="284382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-ZA" sz="12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SP1</a:t>
              </a:r>
              <a:r>
                <a:rPr lang="en-ZA" sz="1200" b="1" baseline="300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42-61</a:t>
              </a:r>
              <a:r>
                <a:rPr lang="en-ZA" sz="12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native fragment</a:t>
              </a:r>
              <a:endParaRPr lang="es-CO" sz="1200" b="1" dirty="0"/>
            </a:p>
          </p:txBody>
        </p:sp>
        <p:sp>
          <p:nvSpPr>
            <p:cNvPr id="4" name="CuadroTexto 3">
              <a:extLst>
                <a:ext uri="{FF2B5EF4-FFF2-40B4-BE49-F238E27FC236}">
                  <a16:creationId xmlns:a16="http://schemas.microsoft.com/office/drawing/2014/main" id="{984B200E-C354-5DA3-D017-6D758136E110}"/>
                </a:ext>
              </a:extLst>
            </p:cNvPr>
            <p:cNvSpPr txBox="1"/>
            <p:nvPr/>
          </p:nvSpPr>
          <p:spPr>
            <a:xfrm>
              <a:off x="4273884" y="2102688"/>
              <a:ext cx="344103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-ZA" sz="12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SP-M51-</a:t>
              </a:r>
              <a:r>
                <a:rPr lang="en-ZA" sz="12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  <a:sym typeface="Symbol" panose="05050102010706020507" pitchFamily="18" charset="2"/>
                </a:rPr>
                <a:t></a:t>
              </a:r>
              <a:r>
                <a:rPr lang="en-ZA" sz="12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[CH2NH]-V52 (B1 </a:t>
              </a:r>
              <a:r>
                <a:rPr lang="en-ZA" sz="1200" b="1" dirty="0" err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nalog</a:t>
              </a:r>
              <a:r>
                <a:rPr lang="en-ZA" sz="12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#2)</a:t>
              </a:r>
              <a:endParaRPr lang="es-CO" sz="1200" b="1" dirty="0"/>
            </a:p>
          </p:txBody>
        </p:sp>
        <p:sp>
          <p:nvSpPr>
            <p:cNvPr id="5" name="CuadroTexto 4">
              <a:extLst>
                <a:ext uri="{FF2B5EF4-FFF2-40B4-BE49-F238E27FC236}">
                  <a16:creationId xmlns:a16="http://schemas.microsoft.com/office/drawing/2014/main" id="{FD634114-1179-F4E3-35CA-808C4603CF11}"/>
                </a:ext>
              </a:extLst>
            </p:cNvPr>
            <p:cNvSpPr txBox="1"/>
            <p:nvPr/>
          </p:nvSpPr>
          <p:spPr>
            <a:xfrm>
              <a:off x="7922794" y="2102688"/>
              <a:ext cx="312821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-ZA" sz="12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SP-V52-</a:t>
              </a:r>
              <a:r>
                <a:rPr lang="en-ZA" sz="12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  <a:sym typeface="Symbol" panose="05050102010706020507" pitchFamily="18" charset="2"/>
                </a:rPr>
                <a:t></a:t>
              </a:r>
              <a:r>
                <a:rPr lang="en-ZA" sz="12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[CH2NH]-L53 (B1 </a:t>
              </a:r>
              <a:r>
                <a:rPr lang="en-ZA" sz="1200" b="1" dirty="0" err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nalog</a:t>
              </a:r>
              <a:r>
                <a:rPr lang="en-ZA" sz="12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#1)</a:t>
              </a:r>
              <a:endParaRPr lang="es-CO" sz="1200" b="1" dirty="0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221119C7-FD32-4F8C-B655-93991F799732}"/>
              </a:ext>
            </a:extLst>
          </p:cNvPr>
          <p:cNvSpPr txBox="1"/>
          <p:nvPr/>
        </p:nvSpPr>
        <p:spPr>
          <a:xfrm>
            <a:off x="974690" y="803868"/>
            <a:ext cx="98172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4: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ime evolution of the number of H bonds within peptides MSP1-M51-ψ[CH</a:t>
            </a:r>
            <a:r>
              <a:rPr lang="en-US" sz="1800" baseline="-25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H]-V52 (B1 analog 2) and MSP1-V52-ψ[CH</a:t>
            </a:r>
            <a:r>
              <a:rPr lang="en-US" sz="1800" baseline="-25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H]-L53 (B1 analog 1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727633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upo 8">
            <a:extLst>
              <a:ext uri="{FF2B5EF4-FFF2-40B4-BE49-F238E27FC236}">
                <a16:creationId xmlns:a16="http://schemas.microsoft.com/office/drawing/2014/main" id="{BE843F02-D512-87C4-D565-00A5C75E216C}"/>
              </a:ext>
            </a:extLst>
          </p:cNvPr>
          <p:cNvGrpSpPr/>
          <p:nvPr/>
        </p:nvGrpSpPr>
        <p:grpSpPr>
          <a:xfrm>
            <a:off x="931545" y="992675"/>
            <a:ext cx="10028556" cy="5154125"/>
            <a:chOff x="931545" y="992675"/>
            <a:chExt cx="10028556" cy="5154125"/>
          </a:xfrm>
        </p:grpSpPr>
        <p:pic>
          <p:nvPicPr>
            <p:cNvPr id="2" name="Picture 4" descr="Chart, box and whisker chart&#10;&#10;Description automatically generated">
              <a:extLst>
                <a:ext uri="{FF2B5EF4-FFF2-40B4-BE49-F238E27FC236}">
                  <a16:creationId xmlns:a16="http://schemas.microsoft.com/office/drawing/2014/main" id="{082CB91C-7A0A-F2B2-F303-2E49ACF601A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275"/>
            <a:stretch/>
          </p:blipFill>
          <p:spPr>
            <a:xfrm>
              <a:off x="931545" y="1397000"/>
              <a:ext cx="10028556" cy="4749800"/>
            </a:xfrm>
            <a:prstGeom prst="rect">
              <a:avLst/>
            </a:prstGeom>
          </p:spPr>
        </p:pic>
        <p:sp>
          <p:nvSpPr>
            <p:cNvPr id="3" name="CuadroTexto 2">
              <a:extLst>
                <a:ext uri="{FF2B5EF4-FFF2-40B4-BE49-F238E27FC236}">
                  <a16:creationId xmlns:a16="http://schemas.microsoft.com/office/drawing/2014/main" id="{0E9E4FEE-2C26-D9A5-82E5-4E42CD1E05BB}"/>
                </a:ext>
              </a:extLst>
            </p:cNvPr>
            <p:cNvSpPr txBox="1"/>
            <p:nvPr/>
          </p:nvSpPr>
          <p:spPr>
            <a:xfrm>
              <a:off x="1384241" y="992675"/>
              <a:ext cx="284382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ZA" sz="12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SP1</a:t>
              </a:r>
              <a:r>
                <a:rPr lang="en-ZA" sz="1200" b="1" baseline="300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42-61</a:t>
              </a:r>
              <a:r>
                <a:rPr lang="en-ZA" sz="12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native fragment</a:t>
              </a:r>
              <a:endParaRPr lang="es-CO" sz="1200" b="1" dirty="0"/>
            </a:p>
          </p:txBody>
        </p:sp>
        <p:sp>
          <p:nvSpPr>
            <p:cNvPr id="4" name="CuadroTexto 3">
              <a:extLst>
                <a:ext uri="{FF2B5EF4-FFF2-40B4-BE49-F238E27FC236}">
                  <a16:creationId xmlns:a16="http://schemas.microsoft.com/office/drawing/2014/main" id="{DEFEE9A1-DFFA-E634-C509-A2A853713975}"/>
                </a:ext>
              </a:extLst>
            </p:cNvPr>
            <p:cNvSpPr txBox="1"/>
            <p:nvPr/>
          </p:nvSpPr>
          <p:spPr>
            <a:xfrm>
              <a:off x="4513179" y="992675"/>
              <a:ext cx="3441033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ZA" sz="12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SP-M51-</a:t>
              </a:r>
              <a:r>
                <a:rPr lang="en-ZA" sz="12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  <a:sym typeface="Symbol" panose="05050102010706020507" pitchFamily="18" charset="2"/>
                </a:rPr>
                <a:t></a:t>
              </a:r>
              <a:r>
                <a:rPr lang="en-ZA" sz="12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[CH2NH]-V52 (B1 </a:t>
              </a:r>
              <a:r>
                <a:rPr lang="en-ZA" sz="1200" b="1" dirty="0" err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nalog</a:t>
              </a:r>
              <a:r>
                <a:rPr lang="en-ZA" sz="12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#2)</a:t>
              </a:r>
              <a:endParaRPr lang="es-CO" sz="1200" b="1" dirty="0"/>
            </a:p>
          </p:txBody>
        </p:sp>
        <p:sp>
          <p:nvSpPr>
            <p:cNvPr id="5" name="CuadroTexto 4">
              <a:extLst>
                <a:ext uri="{FF2B5EF4-FFF2-40B4-BE49-F238E27FC236}">
                  <a16:creationId xmlns:a16="http://schemas.microsoft.com/office/drawing/2014/main" id="{820E4255-3CF4-5505-0455-3E2EAE65FFB9}"/>
                </a:ext>
              </a:extLst>
            </p:cNvPr>
            <p:cNvSpPr txBox="1"/>
            <p:nvPr/>
          </p:nvSpPr>
          <p:spPr>
            <a:xfrm>
              <a:off x="7831889" y="992675"/>
              <a:ext cx="3128212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ZA" sz="12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SP-V52-</a:t>
              </a:r>
              <a:r>
                <a:rPr lang="en-ZA" sz="12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  <a:sym typeface="Symbol" panose="05050102010706020507" pitchFamily="18" charset="2"/>
                </a:rPr>
                <a:t></a:t>
              </a:r>
              <a:r>
                <a:rPr lang="en-ZA" sz="12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[CH2NH]-L53 (B1 </a:t>
              </a:r>
              <a:r>
                <a:rPr lang="en-ZA" sz="1200" b="1" dirty="0" err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nalog</a:t>
              </a:r>
              <a:r>
                <a:rPr lang="en-ZA" sz="12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#1)</a:t>
              </a:r>
              <a:endParaRPr lang="es-CO" sz="1200" b="1" dirty="0"/>
            </a:p>
          </p:txBody>
        </p:sp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DAAE382B-C656-1612-E04F-8C30D073D307}"/>
                </a:ext>
              </a:extLst>
            </p:cNvPr>
            <p:cNvSpPr txBox="1"/>
            <p:nvPr/>
          </p:nvSpPr>
          <p:spPr>
            <a:xfrm>
              <a:off x="1384241" y="3723175"/>
              <a:ext cx="284382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ZA" sz="12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SP1</a:t>
              </a:r>
              <a:r>
                <a:rPr lang="en-ZA" sz="1200" b="1" baseline="300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42-61</a:t>
              </a:r>
              <a:r>
                <a:rPr lang="en-ZA" sz="12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native fragment</a:t>
              </a:r>
              <a:endParaRPr lang="es-CO" sz="1200" b="1" dirty="0"/>
            </a:p>
          </p:txBody>
        </p:sp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9A4C5853-F4CF-9A94-DA65-F1C0CF058297}"/>
                </a:ext>
              </a:extLst>
            </p:cNvPr>
            <p:cNvSpPr txBox="1"/>
            <p:nvPr/>
          </p:nvSpPr>
          <p:spPr>
            <a:xfrm>
              <a:off x="4513179" y="3723175"/>
              <a:ext cx="3441033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ZA" sz="12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SP-M51-</a:t>
              </a:r>
              <a:r>
                <a:rPr lang="en-ZA" sz="12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  <a:sym typeface="Symbol" panose="05050102010706020507" pitchFamily="18" charset="2"/>
                </a:rPr>
                <a:t></a:t>
              </a:r>
              <a:r>
                <a:rPr lang="en-ZA" sz="12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[CH2NH]-V52 (B1 </a:t>
              </a:r>
              <a:r>
                <a:rPr lang="en-ZA" sz="1200" b="1" dirty="0" err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nalog</a:t>
              </a:r>
              <a:r>
                <a:rPr lang="en-ZA" sz="12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#2)</a:t>
              </a:r>
              <a:endParaRPr lang="es-CO" sz="1200" b="1" dirty="0"/>
            </a:p>
          </p:txBody>
        </p:sp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13FAF7DE-DE7C-2ADA-3CE4-38F08339845C}"/>
                </a:ext>
              </a:extLst>
            </p:cNvPr>
            <p:cNvSpPr txBox="1"/>
            <p:nvPr/>
          </p:nvSpPr>
          <p:spPr>
            <a:xfrm>
              <a:off x="7831889" y="3723175"/>
              <a:ext cx="3128212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ZA" sz="12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SP-V52-</a:t>
              </a:r>
              <a:r>
                <a:rPr lang="en-ZA" sz="12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  <a:sym typeface="Symbol" panose="05050102010706020507" pitchFamily="18" charset="2"/>
                </a:rPr>
                <a:t></a:t>
              </a:r>
              <a:r>
                <a:rPr lang="en-ZA" sz="12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[CH2NH]-L53 (B1 </a:t>
              </a:r>
              <a:r>
                <a:rPr lang="en-ZA" sz="1200" b="1" dirty="0" err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nalog</a:t>
              </a:r>
              <a:r>
                <a:rPr lang="en-ZA" sz="12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#1)</a:t>
              </a:r>
              <a:endParaRPr lang="es-CO" sz="1200" b="1" dirty="0"/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7B8C7B9A-DF3F-4DE0-AA12-62B00C6697C5}"/>
              </a:ext>
            </a:extLst>
          </p:cNvPr>
          <p:cNvSpPr txBox="1"/>
          <p:nvPr/>
        </p:nvSpPr>
        <p:spPr>
          <a:xfrm>
            <a:off x="1095271" y="180870"/>
            <a:ext cx="96966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5: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ASA time evolution and boxplots for MSP1-M51-ψ[CH</a:t>
            </a:r>
            <a:r>
              <a:rPr lang="en-US" sz="1800" baseline="-25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H]-V52 (B1 analog 2) and MSP1-V52-ψ[CH</a:t>
            </a:r>
            <a:r>
              <a:rPr lang="en-US" sz="1800" baseline="-25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H]-L53 (B1 analog 1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6481527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3EB7833F-CF03-E3DE-1AB4-7709585B225B}"/>
              </a:ext>
            </a:extLst>
          </p:cNvPr>
          <p:cNvSpPr txBox="1"/>
          <p:nvPr/>
        </p:nvSpPr>
        <p:spPr>
          <a:xfrm>
            <a:off x="7879862" y="3353119"/>
            <a:ext cx="344103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ZA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SP-M51-</a:t>
            </a:r>
            <a:r>
              <a:rPr lang="en-ZA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  <a:sym typeface="Symbol" panose="05050102010706020507" pitchFamily="18" charset="2"/>
              </a:rPr>
              <a:t></a:t>
            </a:r>
            <a:r>
              <a:rPr lang="en-ZA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[CH2NH]-V52 (B1 </a:t>
            </a:r>
            <a:r>
              <a:rPr lang="en-ZA" sz="14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alog</a:t>
            </a:r>
            <a:r>
              <a:rPr lang="en-ZA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#2)</a:t>
            </a:r>
            <a:endParaRPr lang="es-CO" sz="1400" b="1" dirty="0"/>
          </a:p>
        </p:txBody>
      </p:sp>
      <p:grpSp>
        <p:nvGrpSpPr>
          <p:cNvPr id="7" name="Grupo 6">
            <a:extLst>
              <a:ext uri="{FF2B5EF4-FFF2-40B4-BE49-F238E27FC236}">
                <a16:creationId xmlns:a16="http://schemas.microsoft.com/office/drawing/2014/main" id="{8677D948-EF8A-7889-47D4-EC8B3C8EA7FD}"/>
              </a:ext>
            </a:extLst>
          </p:cNvPr>
          <p:cNvGrpSpPr/>
          <p:nvPr/>
        </p:nvGrpSpPr>
        <p:grpSpPr>
          <a:xfrm>
            <a:off x="1452803" y="998565"/>
            <a:ext cx="8987434" cy="5412283"/>
            <a:chOff x="1503045" y="315277"/>
            <a:chExt cx="10311968" cy="6422392"/>
          </a:xfrm>
        </p:grpSpPr>
        <p:pic>
          <p:nvPicPr>
            <p:cNvPr id="2" name="Picture 5" descr="A picture containing graphical user interface&#10;&#10;Description automatically generated">
              <a:extLst>
                <a:ext uri="{FF2B5EF4-FFF2-40B4-BE49-F238E27FC236}">
                  <a16:creationId xmlns:a16="http://schemas.microsoft.com/office/drawing/2014/main" id="{12C92FA2-8D68-A9B7-3173-DED0815B8CF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217"/>
            <a:stretch/>
          </p:blipFill>
          <p:spPr>
            <a:xfrm>
              <a:off x="1503045" y="315277"/>
              <a:ext cx="7183756" cy="6422392"/>
            </a:xfrm>
            <a:prstGeom prst="rect">
              <a:avLst/>
            </a:prstGeom>
          </p:spPr>
        </p:pic>
        <p:sp>
          <p:nvSpPr>
            <p:cNvPr id="3" name="CuadroTexto 2">
              <a:extLst>
                <a:ext uri="{FF2B5EF4-FFF2-40B4-BE49-F238E27FC236}">
                  <a16:creationId xmlns:a16="http://schemas.microsoft.com/office/drawing/2014/main" id="{92B54390-5BF9-014F-2223-642A5CD6E462}"/>
                </a:ext>
              </a:extLst>
            </p:cNvPr>
            <p:cNvSpPr txBox="1"/>
            <p:nvPr/>
          </p:nvSpPr>
          <p:spPr>
            <a:xfrm>
              <a:off x="8795568" y="1302017"/>
              <a:ext cx="2843829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ZA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SP1</a:t>
              </a:r>
              <a:r>
                <a:rPr lang="en-ZA" sz="1400" b="1" baseline="300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42-61</a:t>
              </a:r>
              <a:r>
                <a:rPr lang="en-ZA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native fragment</a:t>
              </a:r>
              <a:endParaRPr lang="es-CO" sz="1400" b="1" dirty="0"/>
            </a:p>
          </p:txBody>
        </p:sp>
        <p:sp>
          <p:nvSpPr>
            <p:cNvPr id="5" name="CuadroTexto 4">
              <a:extLst>
                <a:ext uri="{FF2B5EF4-FFF2-40B4-BE49-F238E27FC236}">
                  <a16:creationId xmlns:a16="http://schemas.microsoft.com/office/drawing/2014/main" id="{96BEF8EC-AAF9-E2E0-5B57-93D5D77553FC}"/>
                </a:ext>
              </a:extLst>
            </p:cNvPr>
            <p:cNvSpPr txBox="1"/>
            <p:nvPr/>
          </p:nvSpPr>
          <p:spPr>
            <a:xfrm>
              <a:off x="8686801" y="4764575"/>
              <a:ext cx="3128212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ZA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SP-V52-</a:t>
              </a:r>
              <a:r>
                <a:rPr lang="en-ZA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  <a:sym typeface="Symbol" panose="05050102010706020507" pitchFamily="18" charset="2"/>
                </a:rPr>
                <a:t></a:t>
              </a:r>
              <a:r>
                <a:rPr lang="en-ZA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[CH2NH]-L53 (B1 </a:t>
              </a:r>
              <a:r>
                <a:rPr lang="en-ZA" sz="1400" b="1" dirty="0" err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nalog</a:t>
              </a:r>
              <a:r>
                <a:rPr lang="en-ZA" sz="14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#1)</a:t>
              </a:r>
              <a:endParaRPr lang="es-CO" sz="1400" b="1" dirty="0"/>
            </a:p>
          </p:txBody>
        </p:sp>
        <p:sp>
          <p:nvSpPr>
            <p:cNvPr id="6" name="Rectángulo 5">
              <a:extLst>
                <a:ext uri="{FF2B5EF4-FFF2-40B4-BE49-F238E27FC236}">
                  <a16:creationId xmlns:a16="http://schemas.microsoft.com/office/drawing/2014/main" id="{DBEA1926-E9EC-8947-15CD-8E8E9DEF7E72}"/>
                </a:ext>
              </a:extLst>
            </p:cNvPr>
            <p:cNvSpPr/>
            <p:nvPr/>
          </p:nvSpPr>
          <p:spPr>
            <a:xfrm>
              <a:off x="8648701" y="685800"/>
              <a:ext cx="228599" cy="1498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CO"/>
            </a:p>
          </p:txBody>
        </p: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D0D9A633-E0F0-42DB-8056-901C91F692CD}"/>
              </a:ext>
            </a:extLst>
          </p:cNvPr>
          <p:cNvSpPr txBox="1"/>
          <p:nvPr/>
        </p:nvSpPr>
        <p:spPr>
          <a:xfrm>
            <a:off x="864158" y="346923"/>
            <a:ext cx="1012873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6: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ime evolution in secondary structure changes in MSP1-M51-ψ[CH</a:t>
            </a:r>
            <a:r>
              <a:rPr lang="en-US" sz="1800" baseline="-25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H]-V52 (B1 analog 2) and MSP1-V52-ψ[CH</a:t>
            </a:r>
            <a:r>
              <a:rPr lang="en-US" sz="1800" baseline="-25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H]-L53 (B1 analog 1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0324999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6" descr="A picture containing diagram&#10;&#10;Description automatically generated">
            <a:extLst>
              <a:ext uri="{FF2B5EF4-FFF2-40B4-BE49-F238E27FC236}">
                <a16:creationId xmlns:a16="http://schemas.microsoft.com/office/drawing/2014/main" id="{247B6E59-6683-6657-197B-21508558832D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80" t="39409" r="10272" b="52669"/>
          <a:stretch/>
        </p:blipFill>
        <p:spPr bwMode="auto">
          <a:xfrm>
            <a:off x="1007115" y="5274128"/>
            <a:ext cx="9352046" cy="491671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5" name="Picture 6" descr="A picture containing diagram&#10;&#10;Description automatically generated">
            <a:extLst>
              <a:ext uri="{FF2B5EF4-FFF2-40B4-BE49-F238E27FC236}">
                <a16:creationId xmlns:a16="http://schemas.microsoft.com/office/drawing/2014/main" id="{B45CDA3A-4D5B-A896-85C8-88687D3852BB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80" t="9677" r="10272" b="61527"/>
          <a:stretch/>
        </p:blipFill>
        <p:spPr bwMode="auto">
          <a:xfrm>
            <a:off x="138220" y="2725058"/>
            <a:ext cx="11915559" cy="2276927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6" name="CuadroTexto 5">
            <a:extLst>
              <a:ext uri="{FF2B5EF4-FFF2-40B4-BE49-F238E27FC236}">
                <a16:creationId xmlns:a16="http://schemas.microsoft.com/office/drawing/2014/main" id="{BD975C42-0AA1-213B-ADF0-55B0141825BB}"/>
              </a:ext>
            </a:extLst>
          </p:cNvPr>
          <p:cNvSpPr txBox="1"/>
          <p:nvPr/>
        </p:nvSpPr>
        <p:spPr>
          <a:xfrm>
            <a:off x="1139503" y="2299026"/>
            <a:ext cx="284382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ZA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SP1</a:t>
            </a:r>
            <a:r>
              <a:rPr lang="en-ZA" sz="1400" b="1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2-61</a:t>
            </a:r>
            <a:r>
              <a:rPr lang="en-ZA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native fragment</a:t>
            </a:r>
            <a:endParaRPr lang="es-CO" sz="1400" b="1" dirty="0"/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75A61D4E-DF7F-D128-DA09-6529507BDF16}"/>
              </a:ext>
            </a:extLst>
          </p:cNvPr>
          <p:cNvSpPr txBox="1"/>
          <p:nvPr/>
        </p:nvSpPr>
        <p:spPr>
          <a:xfrm>
            <a:off x="4268441" y="2299026"/>
            <a:ext cx="344103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ZA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SP-M51-</a:t>
            </a:r>
            <a:r>
              <a:rPr lang="en-ZA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  <a:sym typeface="Symbol" panose="05050102010706020507" pitchFamily="18" charset="2"/>
              </a:rPr>
              <a:t></a:t>
            </a:r>
            <a:r>
              <a:rPr lang="en-ZA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[CH2NH]-V52 (B1 </a:t>
            </a:r>
            <a:r>
              <a:rPr lang="en-ZA" sz="14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alog</a:t>
            </a:r>
            <a:r>
              <a:rPr lang="en-ZA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#2)</a:t>
            </a:r>
            <a:endParaRPr lang="es-CO" sz="1400" b="1" dirty="0"/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4EF63FE3-9BBF-E447-9513-1C693AA26B78}"/>
              </a:ext>
            </a:extLst>
          </p:cNvPr>
          <p:cNvSpPr txBox="1"/>
          <p:nvPr/>
        </p:nvSpPr>
        <p:spPr>
          <a:xfrm>
            <a:off x="7587151" y="2299026"/>
            <a:ext cx="312821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ZA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SP-V52-</a:t>
            </a:r>
            <a:r>
              <a:rPr lang="en-ZA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  <a:sym typeface="Symbol" panose="05050102010706020507" pitchFamily="18" charset="2"/>
              </a:rPr>
              <a:t></a:t>
            </a:r>
            <a:r>
              <a:rPr lang="en-ZA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[CH2NH]-L53 (B1 </a:t>
            </a:r>
            <a:r>
              <a:rPr lang="en-ZA" sz="14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alog</a:t>
            </a:r>
            <a:r>
              <a:rPr lang="en-ZA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#1)</a:t>
            </a:r>
            <a:endParaRPr lang="es-CO" sz="1400" b="1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B032F6C-F886-4E35-9975-D1F2ED75234D}"/>
              </a:ext>
            </a:extLst>
          </p:cNvPr>
          <p:cNvSpPr txBox="1"/>
          <p:nvPr/>
        </p:nvSpPr>
        <p:spPr>
          <a:xfrm>
            <a:off x="1386673" y="512466"/>
            <a:ext cx="93286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7: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epresentative structure of peptides from simulations at different time point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2677348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472</Words>
  <Application>Microsoft Office PowerPoint</Application>
  <PresentationFormat>Widescreen</PresentationFormat>
  <Paragraphs>48</Paragraphs>
  <Slides>7</Slides>
  <Notes>7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Palatino Linotype</vt:lpstr>
      <vt:lpstr>Tema de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ose Manuel Lozano Moreno</dc:creator>
  <cp:lastModifiedBy>MDPI</cp:lastModifiedBy>
  <cp:revision>10</cp:revision>
  <dcterms:created xsi:type="dcterms:W3CDTF">2023-01-26T22:30:24Z</dcterms:created>
  <dcterms:modified xsi:type="dcterms:W3CDTF">2023-03-10T04:56:24Z</dcterms:modified>
</cp:coreProperties>
</file>